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76C0D5-FE72-4029-A6D3-143874C46FE9}" v="1" dt="2020-05-10T15:32:03.1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255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homas Duguet" userId="a91692563c359211" providerId="LiveId" clId="{9576C0D5-FE72-4029-A6D3-143874C46FE9}"/>
    <pc:docChg chg="addSld delSld modSld">
      <pc:chgData name="Thomas Duguet" userId="a91692563c359211" providerId="LiveId" clId="{9576C0D5-FE72-4029-A6D3-143874C46FE9}" dt="2020-05-10T15:32:06.509" v="1" actId="2696"/>
      <pc:docMkLst>
        <pc:docMk/>
      </pc:docMkLst>
      <pc:sldChg chg="del">
        <pc:chgData name="Thomas Duguet" userId="a91692563c359211" providerId="LiveId" clId="{9576C0D5-FE72-4029-A6D3-143874C46FE9}" dt="2020-05-10T15:32:06.509" v="1" actId="2696"/>
        <pc:sldMkLst>
          <pc:docMk/>
          <pc:sldMk cId="4126939010" sldId="257"/>
        </pc:sldMkLst>
      </pc:sldChg>
      <pc:sldChg chg="add">
        <pc:chgData name="Thomas Duguet" userId="a91692563c359211" providerId="LiveId" clId="{9576C0D5-FE72-4029-A6D3-143874C46FE9}" dt="2020-05-10T15:32:03.102" v="0"/>
        <pc:sldMkLst>
          <pc:docMk/>
          <pc:sldMk cId="3129255920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1697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5793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237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9968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2445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6717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6297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88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0073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7792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4364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179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1635FF9C-A49B-427F-BC33-C94D0E8A4251}"/>
              </a:ext>
            </a:extLst>
          </p:cNvPr>
          <p:cNvGraphicFramePr>
            <a:graphicFrameLocks noGrp="1" noChangeAspect="1"/>
          </p:cNvGraphicFramePr>
          <p:nvPr/>
        </p:nvGraphicFramePr>
        <p:xfrm>
          <a:off x="2295686" y="523042"/>
          <a:ext cx="931565" cy="85706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31565">
                  <a:extLst>
                    <a:ext uri="{9D8B030D-6E8A-4147-A177-3AD203B41FA5}">
                      <a16:colId xmlns:a16="http://schemas.microsoft.com/office/drawing/2014/main" val="1024137856"/>
                    </a:ext>
                  </a:extLst>
                </a:gridCol>
              </a:tblGrid>
              <a:tr h="121124"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  <a:endParaRPr lang="en-CA" sz="7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94003203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aziquantel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07655671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dip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959679451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-619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27628509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125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18217695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N-212854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71880095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C69792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75712248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-3867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32556238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2077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77467262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trandr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44962366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eQ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06549541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D346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717445509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S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25965216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cidip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84418360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-822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80398627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ilonium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582799269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-J4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30838636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S-214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642925129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fithrin-µ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64970767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golid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05799135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K 73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74343276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-)-</a:t>
                      </a:r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thenolid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82337526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odaro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64244282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monabant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77902503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piprazol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782763919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K378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62237764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ifenacin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653705631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EP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36850662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C319726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74807297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op-016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16696456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enprodil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5883095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B743921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87962886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ecol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04623648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oxet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39266705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R-124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88380236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G-07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86872803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TC-801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25689259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pinesib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42844619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tic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25423778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izartinib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4736585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-5274857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95267441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etomid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81084949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S-833923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67162123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Q 621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70964451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D9291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8953047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zap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63745073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fenacin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88351786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golimod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99976153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promaz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66696551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M155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42668989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ucaloprid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18381574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oxam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89939031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prothixe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743976470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radiol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91012588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xet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65890497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U-03012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16570263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K15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51565225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iprasido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86999367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Z4002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53942820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I-1776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313676897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italopram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191365627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rtioxet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01473414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rutinib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04932572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T1720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881193435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191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6728034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stunolid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375149986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mife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591556738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stode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327080192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triptyl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235000223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renogest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425764673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loxet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051416601"/>
                  </a:ext>
                </a:extLst>
              </a:tr>
              <a:tr h="119007"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oxetine</a:t>
                      </a:r>
                    </a:p>
                  </a:txBody>
                  <a:tcPr marL="8955" marR="8955" marT="9525" marB="0" anchor="b"/>
                </a:tc>
                <a:extLst>
                  <a:ext uri="{0D108BD9-81ED-4DB2-BD59-A6C34878D82A}">
                    <a16:rowId xmlns:a16="http://schemas.microsoft.com/office/drawing/2014/main" val="3256988353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F0A166F9-2E86-4361-A8B8-3CA97AD2C617}"/>
              </a:ext>
            </a:extLst>
          </p:cNvPr>
          <p:cNvSpPr txBox="1">
            <a:spLocks noChangeAspect="1"/>
          </p:cNvSpPr>
          <p:nvPr/>
        </p:nvSpPr>
        <p:spPr>
          <a:xfrm rot="18289869">
            <a:off x="2746680" y="32068"/>
            <a:ext cx="14207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male ; d1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6EECFC-C7AD-4490-8C84-1DAEC9423C6B}"/>
              </a:ext>
            </a:extLst>
          </p:cNvPr>
          <p:cNvSpPr txBox="1">
            <a:spLocks noChangeAspect="1"/>
          </p:cNvSpPr>
          <p:nvPr/>
        </p:nvSpPr>
        <p:spPr>
          <a:xfrm rot="18289869">
            <a:off x="3061756" y="7309"/>
            <a:ext cx="14207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; d1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A21F93-3E77-405F-A974-DA94F1774CBC}"/>
              </a:ext>
            </a:extLst>
          </p:cNvPr>
          <p:cNvSpPr txBox="1">
            <a:spLocks noChangeAspect="1"/>
          </p:cNvSpPr>
          <p:nvPr/>
        </p:nvSpPr>
        <p:spPr>
          <a:xfrm rot="18289869">
            <a:off x="4080259" y="46354"/>
            <a:ext cx="14207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male ; d7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DE765A-54C5-43E1-930F-CE6C740E19AB}"/>
              </a:ext>
            </a:extLst>
          </p:cNvPr>
          <p:cNvSpPr txBox="1">
            <a:spLocks noChangeAspect="1"/>
          </p:cNvSpPr>
          <p:nvPr/>
        </p:nvSpPr>
        <p:spPr>
          <a:xfrm rot="18289869">
            <a:off x="4427604" y="33170"/>
            <a:ext cx="14207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; d7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D2E9260-E31D-48C9-9A63-9BDE51D0A652}"/>
              </a:ext>
            </a:extLst>
          </p:cNvPr>
          <p:cNvGrpSpPr>
            <a:grpSpLocks noChangeAspect="1"/>
          </p:cNvGrpSpPr>
          <p:nvPr/>
        </p:nvGrpSpPr>
        <p:grpSpPr>
          <a:xfrm>
            <a:off x="4295368" y="648146"/>
            <a:ext cx="694635" cy="8798402"/>
            <a:chOff x="-1706572" y="716000"/>
            <a:chExt cx="738975" cy="851638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A86C347-D0E6-40AD-913B-FB64E856B8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3877" t="6864" r="14095"/>
            <a:stretch/>
          </p:blipFill>
          <p:spPr>
            <a:xfrm>
              <a:off x="-1706572" y="716000"/>
              <a:ext cx="738973" cy="851638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56D22A8-B48B-4C21-A4EE-529C7EE965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74974" t="6864" r="13007"/>
            <a:stretch/>
          </p:blipFill>
          <p:spPr>
            <a:xfrm>
              <a:off x="-1697651" y="716000"/>
              <a:ext cx="730054" cy="8516380"/>
            </a:xfrm>
            <a:prstGeom prst="rect">
              <a:avLst/>
            </a:prstGeom>
          </p:spPr>
        </p:pic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4A518C8-A7AD-4C26-B90B-F303CF7D83D7}"/>
              </a:ext>
            </a:extLst>
          </p:cNvPr>
          <p:cNvGrpSpPr>
            <a:grpSpLocks noChangeAspect="1"/>
          </p:cNvGrpSpPr>
          <p:nvPr/>
        </p:nvGrpSpPr>
        <p:grpSpPr>
          <a:xfrm>
            <a:off x="2924891" y="628813"/>
            <a:ext cx="707735" cy="8832242"/>
            <a:chOff x="9875519" y="-981307"/>
            <a:chExt cx="752909" cy="8535424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6269D373-7B69-45B9-B73F-62A119382C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715" t="6655" r="70175"/>
            <a:stretch/>
          </p:blipFill>
          <p:spPr>
            <a:xfrm>
              <a:off x="9875519" y="-981307"/>
              <a:ext cx="743989" cy="8535424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1AC53461-B83E-4002-AF0F-B366688699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18024" t="6655" r="69728"/>
            <a:stretch/>
          </p:blipFill>
          <p:spPr>
            <a:xfrm>
              <a:off x="9884440" y="-981307"/>
              <a:ext cx="743988" cy="8535424"/>
            </a:xfrm>
            <a:prstGeom prst="rect">
              <a:avLst/>
            </a:prstGeom>
          </p:spPr>
        </p:pic>
      </p:grpSp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276EE282-E4BA-4862-BADC-7128D94A1DC2}"/>
              </a:ext>
            </a:extLst>
          </p:cNvPr>
          <p:cNvGraphicFramePr>
            <a:graphicFrameLocks noGrp="1" noChangeAspect="1"/>
          </p:cNvGraphicFramePr>
          <p:nvPr/>
        </p:nvGraphicFramePr>
        <p:xfrm>
          <a:off x="2956034" y="658142"/>
          <a:ext cx="610176" cy="84491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0259">
                  <a:extLst>
                    <a:ext uri="{9D8B030D-6E8A-4147-A177-3AD203B41FA5}">
                      <a16:colId xmlns:a16="http://schemas.microsoft.com/office/drawing/2014/main" val="1884222136"/>
                    </a:ext>
                  </a:extLst>
                </a:gridCol>
                <a:gridCol w="309917">
                  <a:extLst>
                    <a:ext uri="{9D8B030D-6E8A-4147-A177-3AD203B41FA5}">
                      <a16:colId xmlns:a16="http://schemas.microsoft.com/office/drawing/2014/main" val="1024137856"/>
                    </a:ext>
                  </a:extLst>
                </a:gridCol>
              </a:tblGrid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5827515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9679451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628509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217695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880095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12248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556238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467262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62366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54954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1744550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96521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418360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98627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279926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83863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292512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97076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799135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43276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37526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44282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902503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276391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237764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3705631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850662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807297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696456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83095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962886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623648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266705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380236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872803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89259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844619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423778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736585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67441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084949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16212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96445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53047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745073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35178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976153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69655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668989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381574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939031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97647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012588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89049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57026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565225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6999367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942820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367689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365627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47341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4932572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11934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28034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825710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362119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350880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366256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737438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3878228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7580260"/>
                  </a:ext>
                </a:extLst>
              </a:tr>
            </a:tbl>
          </a:graphicData>
        </a:graphic>
      </p:graphicFrame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79E6302E-1170-4B9F-8C87-0A15A0CDEE97}"/>
              </a:ext>
            </a:extLst>
          </p:cNvPr>
          <p:cNvGraphicFramePr>
            <a:graphicFrameLocks noGrp="1" noChangeAspect="1"/>
          </p:cNvGraphicFramePr>
          <p:nvPr/>
        </p:nvGraphicFramePr>
        <p:xfrm>
          <a:off x="4332546" y="658142"/>
          <a:ext cx="606064" cy="84491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8235">
                  <a:extLst>
                    <a:ext uri="{9D8B030D-6E8A-4147-A177-3AD203B41FA5}">
                      <a16:colId xmlns:a16="http://schemas.microsoft.com/office/drawing/2014/main" val="1884222136"/>
                    </a:ext>
                  </a:extLst>
                </a:gridCol>
                <a:gridCol w="307829">
                  <a:extLst>
                    <a:ext uri="{9D8B030D-6E8A-4147-A177-3AD203B41FA5}">
                      <a16:colId xmlns:a16="http://schemas.microsoft.com/office/drawing/2014/main" val="1024137856"/>
                    </a:ext>
                  </a:extLst>
                </a:gridCol>
              </a:tblGrid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5827515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9679451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628509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217695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880095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12248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556238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467262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62366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54954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1744550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96521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418360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98627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279926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83863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292512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97076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799135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43276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37526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44282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902503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2763919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237764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3705631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850662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807297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696456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83095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962886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623648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266705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380236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872803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89259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844619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423778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736585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67441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084949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16212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96445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53047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745073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351786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976153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696551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668989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381574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939031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97647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012588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89049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57026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565225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6999367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942820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367689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3656276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473414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4932572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1193435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28034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825710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3621193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3508808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3662562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73743877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38782280"/>
                  </a:ext>
                </a:extLst>
              </a:tr>
              <a:tr h="119002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55" marR="895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7580260"/>
                  </a:ext>
                </a:extLst>
              </a:tr>
            </a:tbl>
          </a:graphicData>
        </a:graphic>
      </p:graphicFrame>
      <p:pic>
        <p:nvPicPr>
          <p:cNvPr id="22" name="Picture 21">
            <a:extLst>
              <a:ext uri="{FF2B5EF4-FFF2-40B4-BE49-F238E27FC236}">
                <a16:creationId xmlns:a16="http://schemas.microsoft.com/office/drawing/2014/main" id="{C986198E-B82D-418C-BC9A-15667D2995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9024" t="6602" r="6326" b="4321"/>
          <a:stretch/>
        </p:blipFill>
        <p:spPr>
          <a:xfrm rot="10800000">
            <a:off x="5102607" y="5041420"/>
            <a:ext cx="159259" cy="410638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D881AA7-2724-4843-B597-08C25E497B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1479" t="6045" r="63082" b="4131"/>
          <a:stretch/>
        </p:blipFill>
        <p:spPr>
          <a:xfrm rot="10800000">
            <a:off x="3712422" y="5071158"/>
            <a:ext cx="184570" cy="409091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9E1F66DF-EF63-457F-8173-3089B17A98C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6685" t="8455" r="7305"/>
          <a:stretch/>
        </p:blipFill>
        <p:spPr>
          <a:xfrm rot="10800000">
            <a:off x="5088371" y="525422"/>
            <a:ext cx="200515" cy="412760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3E9BD53F-263B-4698-8D01-76563F38D7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6685" t="8455" r="7305"/>
          <a:stretch/>
        </p:blipFill>
        <p:spPr>
          <a:xfrm rot="10800000">
            <a:off x="3713013" y="523041"/>
            <a:ext cx="217600" cy="4127603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DBD6831-1769-48BB-A610-33A223DAB61D}"/>
              </a:ext>
            </a:extLst>
          </p:cNvPr>
          <p:cNvSpPr txBox="1">
            <a:spLocks noChangeAspect="1"/>
          </p:cNvSpPr>
          <p:nvPr/>
        </p:nvSpPr>
        <p:spPr>
          <a:xfrm>
            <a:off x="3815218" y="578588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06F6AD8-22AD-4012-A180-82C7C73F6FE2}"/>
              </a:ext>
            </a:extLst>
          </p:cNvPr>
          <p:cNvSpPr txBox="1">
            <a:spLocks noChangeAspect="1"/>
          </p:cNvSpPr>
          <p:nvPr/>
        </p:nvSpPr>
        <p:spPr>
          <a:xfrm>
            <a:off x="3806258" y="1383846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8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9EF34A9-8D31-4CA1-8499-441D019D9012}"/>
              </a:ext>
            </a:extLst>
          </p:cNvPr>
          <p:cNvSpPr txBox="1">
            <a:spLocks noChangeAspect="1"/>
          </p:cNvSpPr>
          <p:nvPr/>
        </p:nvSpPr>
        <p:spPr>
          <a:xfrm>
            <a:off x="3806258" y="2188785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6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3C483F1-2EB0-448D-A46F-C978FACC49DD}"/>
              </a:ext>
            </a:extLst>
          </p:cNvPr>
          <p:cNvSpPr txBox="1">
            <a:spLocks noChangeAspect="1"/>
          </p:cNvSpPr>
          <p:nvPr/>
        </p:nvSpPr>
        <p:spPr>
          <a:xfrm>
            <a:off x="3806258" y="2993724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4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FE8CC85-1187-4FD8-999E-4792F6FEF3F2}"/>
              </a:ext>
            </a:extLst>
          </p:cNvPr>
          <p:cNvSpPr txBox="1">
            <a:spLocks noChangeAspect="1"/>
          </p:cNvSpPr>
          <p:nvPr/>
        </p:nvSpPr>
        <p:spPr>
          <a:xfrm>
            <a:off x="3808353" y="3803425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2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3690A9A-619D-4C91-9CFF-DFBB4F109BBA}"/>
              </a:ext>
            </a:extLst>
          </p:cNvPr>
          <p:cNvSpPr txBox="1">
            <a:spLocks noChangeAspect="1"/>
          </p:cNvSpPr>
          <p:nvPr/>
        </p:nvSpPr>
        <p:spPr>
          <a:xfrm>
            <a:off x="3905792" y="4755110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4A118A4-7295-4860-9399-85EA97DAC272}"/>
              </a:ext>
            </a:extLst>
          </p:cNvPr>
          <p:cNvSpPr txBox="1">
            <a:spLocks noChangeAspect="1"/>
          </p:cNvSpPr>
          <p:nvPr/>
        </p:nvSpPr>
        <p:spPr>
          <a:xfrm>
            <a:off x="3583394" y="4721792"/>
            <a:ext cx="430799" cy="277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</a:p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CADA037-AAA6-4FEF-BA92-78E810BCB968}"/>
              </a:ext>
            </a:extLst>
          </p:cNvPr>
          <p:cNvSpPr txBox="1">
            <a:spLocks noChangeAspect="1"/>
          </p:cNvSpPr>
          <p:nvPr/>
        </p:nvSpPr>
        <p:spPr>
          <a:xfrm>
            <a:off x="3816951" y="5269012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4D5D83-5021-4F13-A7B9-54A6B7086D98}"/>
              </a:ext>
            </a:extLst>
          </p:cNvPr>
          <p:cNvSpPr txBox="1">
            <a:spLocks noChangeAspect="1"/>
          </p:cNvSpPr>
          <p:nvPr/>
        </p:nvSpPr>
        <p:spPr>
          <a:xfrm>
            <a:off x="3815691" y="5891254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E665A32-5FB4-4362-AB37-5833F58E810D}"/>
              </a:ext>
            </a:extLst>
          </p:cNvPr>
          <p:cNvSpPr txBox="1">
            <a:spLocks noChangeAspect="1"/>
          </p:cNvSpPr>
          <p:nvPr/>
        </p:nvSpPr>
        <p:spPr>
          <a:xfrm>
            <a:off x="3814536" y="6519272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DA15706-CAE6-4D85-8BD2-907BDF0BF3A4}"/>
              </a:ext>
            </a:extLst>
          </p:cNvPr>
          <p:cNvSpPr txBox="1">
            <a:spLocks noChangeAspect="1"/>
          </p:cNvSpPr>
          <p:nvPr/>
        </p:nvSpPr>
        <p:spPr>
          <a:xfrm>
            <a:off x="3821308" y="7148845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2592C07-A8F1-4B72-AA84-BBFF794A7E3D}"/>
              </a:ext>
            </a:extLst>
          </p:cNvPr>
          <p:cNvSpPr txBox="1">
            <a:spLocks noChangeAspect="1"/>
          </p:cNvSpPr>
          <p:nvPr/>
        </p:nvSpPr>
        <p:spPr>
          <a:xfrm>
            <a:off x="3806258" y="7769532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2ED7D85-5313-43E0-8E56-B7BE464B5413}"/>
              </a:ext>
            </a:extLst>
          </p:cNvPr>
          <p:cNvSpPr txBox="1">
            <a:spLocks noChangeAspect="1"/>
          </p:cNvSpPr>
          <p:nvPr/>
        </p:nvSpPr>
        <p:spPr>
          <a:xfrm>
            <a:off x="3809067" y="8390219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88FBF0C-9AED-432E-B3B8-7D705C1C65ED}"/>
              </a:ext>
            </a:extLst>
          </p:cNvPr>
          <p:cNvSpPr txBox="1">
            <a:spLocks noChangeAspect="1"/>
          </p:cNvSpPr>
          <p:nvPr/>
        </p:nvSpPr>
        <p:spPr>
          <a:xfrm>
            <a:off x="5183830" y="578588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F02F8AE-0C5F-4F8F-B521-0514F1D8DF1D}"/>
              </a:ext>
            </a:extLst>
          </p:cNvPr>
          <p:cNvSpPr txBox="1">
            <a:spLocks noChangeAspect="1"/>
          </p:cNvSpPr>
          <p:nvPr/>
        </p:nvSpPr>
        <p:spPr>
          <a:xfrm>
            <a:off x="5174870" y="1383846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8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D51CD61-7FAE-4327-A650-C58E26E88C03}"/>
              </a:ext>
            </a:extLst>
          </p:cNvPr>
          <p:cNvSpPr txBox="1">
            <a:spLocks noChangeAspect="1"/>
          </p:cNvSpPr>
          <p:nvPr/>
        </p:nvSpPr>
        <p:spPr>
          <a:xfrm>
            <a:off x="5174870" y="2188785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6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2F3994-8BBF-47E4-9A99-EA0261B5E148}"/>
              </a:ext>
            </a:extLst>
          </p:cNvPr>
          <p:cNvSpPr txBox="1">
            <a:spLocks noChangeAspect="1"/>
          </p:cNvSpPr>
          <p:nvPr/>
        </p:nvSpPr>
        <p:spPr>
          <a:xfrm>
            <a:off x="5174870" y="2993724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4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1147D4D-E1FB-4108-B83B-371DD841996D}"/>
              </a:ext>
            </a:extLst>
          </p:cNvPr>
          <p:cNvSpPr txBox="1">
            <a:spLocks noChangeAspect="1"/>
          </p:cNvSpPr>
          <p:nvPr/>
        </p:nvSpPr>
        <p:spPr>
          <a:xfrm>
            <a:off x="5176965" y="3803425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2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32AF40A-7DA7-4F44-BDE4-35EE13347C19}"/>
              </a:ext>
            </a:extLst>
          </p:cNvPr>
          <p:cNvSpPr txBox="1">
            <a:spLocks noChangeAspect="1"/>
          </p:cNvSpPr>
          <p:nvPr/>
        </p:nvSpPr>
        <p:spPr>
          <a:xfrm>
            <a:off x="5261866" y="4760436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177CC9F-EE4D-4E09-B51F-B2F6D6FA8E9D}"/>
              </a:ext>
            </a:extLst>
          </p:cNvPr>
          <p:cNvSpPr txBox="1">
            <a:spLocks noChangeAspect="1"/>
          </p:cNvSpPr>
          <p:nvPr/>
        </p:nvSpPr>
        <p:spPr>
          <a:xfrm>
            <a:off x="4952006" y="4721792"/>
            <a:ext cx="430799" cy="277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</a:p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435A2A-D336-496E-B0D8-6A1AB6260EEC}"/>
              </a:ext>
            </a:extLst>
          </p:cNvPr>
          <p:cNvSpPr txBox="1">
            <a:spLocks noChangeAspect="1"/>
          </p:cNvSpPr>
          <p:nvPr/>
        </p:nvSpPr>
        <p:spPr>
          <a:xfrm>
            <a:off x="5188628" y="5931990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3C6F6A8-B849-4049-B4DE-4209C700A539}"/>
              </a:ext>
            </a:extLst>
          </p:cNvPr>
          <p:cNvSpPr txBox="1">
            <a:spLocks noChangeAspect="1"/>
          </p:cNvSpPr>
          <p:nvPr/>
        </p:nvSpPr>
        <p:spPr>
          <a:xfrm>
            <a:off x="5208366" y="6965356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DF474F0-89F9-4A00-BD80-B36C139D332B}"/>
              </a:ext>
            </a:extLst>
          </p:cNvPr>
          <p:cNvSpPr txBox="1">
            <a:spLocks noChangeAspect="1"/>
          </p:cNvSpPr>
          <p:nvPr/>
        </p:nvSpPr>
        <p:spPr>
          <a:xfrm>
            <a:off x="5208365" y="7998722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9C486D6-0B2F-4CF1-B042-2A038FD29098}"/>
              </a:ext>
            </a:extLst>
          </p:cNvPr>
          <p:cNvSpPr txBox="1">
            <a:spLocks noChangeAspect="1"/>
          </p:cNvSpPr>
          <p:nvPr/>
        </p:nvSpPr>
        <p:spPr>
          <a:xfrm>
            <a:off x="5208364" y="9017778"/>
            <a:ext cx="979219" cy="173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580B5ED-31EF-4E63-855B-6C7B89DEA76F}"/>
              </a:ext>
            </a:extLst>
          </p:cNvPr>
          <p:cNvSpPr txBox="1">
            <a:spLocks noChangeAspect="1"/>
          </p:cNvSpPr>
          <p:nvPr/>
        </p:nvSpPr>
        <p:spPr>
          <a:xfrm rot="5400000">
            <a:off x="4111825" y="4812243"/>
            <a:ext cx="302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fractional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difference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to control)</a:t>
            </a:r>
            <a:endParaRPr lang="en-CA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CBFE205-E442-42D3-99CB-DB4FBBAD11C6}"/>
              </a:ext>
            </a:extLst>
          </p:cNvPr>
          <p:cNvSpPr txBox="1">
            <a:spLocks noChangeAspect="1"/>
          </p:cNvSpPr>
          <p:nvPr/>
        </p:nvSpPr>
        <p:spPr>
          <a:xfrm>
            <a:off x="3806258" y="9010906"/>
            <a:ext cx="979219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0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3129255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9</Words>
  <Application>Microsoft Office PowerPoint</Application>
  <PresentationFormat>On-screen Show (4:3)</PresentationFormat>
  <Paragraphs>3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Duguet</dc:creator>
  <cp:lastModifiedBy>Thomas Duguet</cp:lastModifiedBy>
  <cp:revision>1</cp:revision>
  <dcterms:created xsi:type="dcterms:W3CDTF">2020-05-10T15:30:36Z</dcterms:created>
  <dcterms:modified xsi:type="dcterms:W3CDTF">2020-05-10T15:32:08Z</dcterms:modified>
</cp:coreProperties>
</file>